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4211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42800" cy="987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210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9600" y="-360"/>
            <a:ext cx="29210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03240" y="739800"/>
            <a:ext cx="4935600" cy="3703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4640" y="4689000"/>
            <a:ext cx="5392800" cy="444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377280"/>
            <a:ext cx="292104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9600" y="9377280"/>
            <a:ext cx="2921040" cy="49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103DD3E-CDED-429D-ADE7-52BF3B35D0F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7"/>
          <p:cNvSpPr/>
          <p:nvPr/>
        </p:nvSpPr>
        <p:spPr>
          <a:xfrm>
            <a:off x="3819600" y="9377280"/>
            <a:ext cx="2921040" cy="49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5518004-553F-440C-BED0-C2C61C6CB11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903240" y="739800"/>
            <a:ext cx="4935600" cy="370368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74640" y="4689000"/>
            <a:ext cx="5392800" cy="444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242A0-DB66-4084-B171-4BA70DD5BE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2EEA9-707D-4FF2-B863-B744615A7A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C1324-0A10-4E57-B951-04E686F16E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21315-0353-4863-AF63-B95E667459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4FAD1-DD47-4E21-A4F3-A6261D6089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FE706-8E5D-4B19-AF0C-CD2AB1784B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E7A88-9A2C-440A-9526-AD89BCE0DF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4427B7-53F6-4692-9A06-799A23EB2F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7C5BE-DCF7-4A3C-A768-EEF92B8BA5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322E10-BD92-4307-BD8E-2AFEEAB520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BE358-2A40-48EE-A65C-D1A8861F8D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B7101-D507-417B-963B-BD04BB332C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77E19ED-F1BE-4BEF-85FD-F9EF8F5C113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"/>
          <p:cNvSpPr/>
          <p:nvPr/>
        </p:nvSpPr>
        <p:spPr>
          <a:xfrm>
            <a:off x="2948040" y="1735200"/>
            <a:ext cx="1658880" cy="3008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4"/>
          <p:cNvSpPr/>
          <p:nvPr/>
        </p:nvSpPr>
        <p:spPr>
          <a:xfrm>
            <a:off x="3098880" y="1971720"/>
            <a:ext cx="1344600" cy="1163520"/>
          </a:xfrm>
          <a:prstGeom prst="rect">
            <a:avLst/>
          </a:prstGeom>
          <a:solidFill>
            <a:srgbClr val="dce6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Threat apprais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5"/>
          <p:cNvSpPr/>
          <p:nvPr/>
        </p:nvSpPr>
        <p:spPr>
          <a:xfrm>
            <a:off x="3087720" y="3327480"/>
            <a:ext cx="1355760" cy="1163520"/>
          </a:xfrm>
          <a:prstGeom prst="rect">
            <a:avLst/>
          </a:prstGeom>
          <a:solidFill>
            <a:srgbClr val="dce6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Coping apprais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7"/>
          <p:cNvSpPr/>
          <p:nvPr/>
        </p:nvSpPr>
        <p:spPr>
          <a:xfrm>
            <a:off x="5106960" y="3565440"/>
            <a:ext cx="1673280" cy="770040"/>
          </a:xfrm>
          <a:prstGeom prst="rect">
            <a:avLst/>
          </a:prstGeom>
          <a:solidFill>
            <a:srgbClr val="dce6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Behavioural intention (protection motivation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5"/>
          <p:cNvSpPr/>
          <p:nvPr/>
        </p:nvSpPr>
        <p:spPr>
          <a:xfrm>
            <a:off x="542880" y="3424320"/>
            <a:ext cx="1612800" cy="1216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spcBef>
                <a:spcPts val="6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Personal non-health-related results from WG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hysical trai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ncestr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9"/>
          <p:cNvSpPr/>
          <p:nvPr/>
        </p:nvSpPr>
        <p:spPr>
          <a:xfrm>
            <a:off x="365040" y="471600"/>
            <a:ext cx="1905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EXTERNAL STIMUL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 Box 20"/>
          <p:cNvSpPr/>
          <p:nvPr/>
        </p:nvSpPr>
        <p:spPr>
          <a:xfrm>
            <a:off x="3643200" y="479520"/>
            <a:ext cx="2632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MESSAGE PROCESSING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24"/>
          <p:cNvSpPr/>
          <p:nvPr/>
        </p:nvSpPr>
        <p:spPr>
          <a:xfrm>
            <a:off x="7186680" y="471600"/>
            <a:ext cx="167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OUTCOM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Line 27"/>
          <p:cNvSpPr/>
          <p:nvPr/>
        </p:nvSpPr>
        <p:spPr>
          <a:xfrm>
            <a:off x="4606920" y="3949560"/>
            <a:ext cx="500040" cy="12960"/>
          </a:xfrm>
          <a:prstGeom prst="line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31"/>
          <p:cNvSpPr/>
          <p:nvPr/>
        </p:nvSpPr>
        <p:spPr>
          <a:xfrm>
            <a:off x="360360" y="6049800"/>
            <a:ext cx="8494560" cy="520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</a:rPr>
              <a:t>Supplemental Figure 1. </a:t>
            </a:r>
            <a:r>
              <a:rPr b="0" lang="en-GB" sz="1400" spc="-1" strike="noStrike">
                <a:solidFill>
                  <a:srgbClr val="000000"/>
                </a:solidFill>
                <a:latin typeface="Calibri"/>
              </a:rPr>
              <a:t>Conceptual framework for the health-related results component of the HealthSeq project outcomes study, based on Protection Motivation Theor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10"/>
          <p:cNvSpPr/>
          <p:nvPr/>
        </p:nvSpPr>
        <p:spPr>
          <a:xfrm>
            <a:off x="7186680" y="3581280"/>
            <a:ext cx="1673280" cy="763560"/>
          </a:xfrm>
          <a:prstGeom prst="rect">
            <a:avLst/>
          </a:prstGeom>
          <a:solidFill>
            <a:srgbClr val="dce6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Behaviou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(protective behaviour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15"/>
          <p:cNvSpPr/>
          <p:nvPr/>
        </p:nvSpPr>
        <p:spPr>
          <a:xfrm>
            <a:off x="365040" y="1127160"/>
            <a:ext cx="1905120" cy="4226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spcBef>
                <a:spcPts val="6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15"/>
          <p:cNvSpPr/>
          <p:nvPr/>
        </p:nvSpPr>
        <p:spPr>
          <a:xfrm>
            <a:off x="542880" y="1306440"/>
            <a:ext cx="1612800" cy="1933560"/>
          </a:xfrm>
          <a:prstGeom prst="rect">
            <a:avLst/>
          </a:prstGeom>
          <a:solidFill>
            <a:srgbClr val="fdeada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spcBef>
                <a:spcPts val="6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Personal health-related results from WG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ingle gene disease (rare variants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Complex disease risk (e.g. SNP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Pharmacogenomic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15"/>
          <p:cNvSpPr/>
          <p:nvPr/>
        </p:nvSpPr>
        <p:spPr>
          <a:xfrm>
            <a:off x="542880" y="4815000"/>
            <a:ext cx="1612800" cy="285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spcBef>
                <a:spcPts val="6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Raw sequence dat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2" name="Straight Arrow Connector 2"/>
          <p:cNvCxnSpPr>
            <a:stCxn id="51" idx="3"/>
            <a:endCxn id="58" idx="1"/>
          </p:cNvCxnSpPr>
          <p:nvPr/>
        </p:nvCxnSpPr>
        <p:spPr>
          <a:xfrm>
            <a:off x="6780240" y="3950280"/>
            <a:ext cx="406800" cy="1296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3" name="Straight Arrow Connector 4"/>
          <p:cNvCxnSpPr/>
          <p:nvPr/>
        </p:nvCxnSpPr>
        <p:spPr>
          <a:xfrm>
            <a:off x="2269800" y="2558520"/>
            <a:ext cx="67860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4" name="Straight Arrow Connector 29"/>
          <p:cNvCxnSpPr/>
          <p:nvPr/>
        </p:nvCxnSpPr>
        <p:spPr>
          <a:xfrm>
            <a:off x="2269800" y="3963600"/>
            <a:ext cx="67860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5" name="Rectangle 7"/>
          <p:cNvSpPr/>
          <p:nvPr/>
        </p:nvSpPr>
        <p:spPr>
          <a:xfrm>
            <a:off x="5106960" y="2173320"/>
            <a:ext cx="1673280" cy="770040"/>
          </a:xfrm>
          <a:prstGeom prst="rect">
            <a:avLst/>
          </a:prstGeom>
          <a:solidFill>
            <a:srgbClr val="dce6f2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Fea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6" name="Straight Arrow Connector 6"/>
          <p:cNvCxnSpPr>
            <a:endCxn id="65" idx="1"/>
          </p:cNvCxnSpPr>
          <p:nvPr/>
        </p:nvCxnSpPr>
        <p:spPr>
          <a:xfrm flipV="1">
            <a:off x="4606560" y="2558160"/>
            <a:ext cx="500760" cy="72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7" name="Straight Arrow Connector 9"/>
          <p:cNvCxnSpPr>
            <a:stCxn id="65" idx="2"/>
            <a:endCxn id="51" idx="0"/>
          </p:cNvCxnSpPr>
          <p:nvPr/>
        </p:nvCxnSpPr>
        <p:spPr>
          <a:xfrm>
            <a:off x="5943600" y="2943360"/>
            <a:ext cx="360" cy="62244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08T12:06:07Z</dcterms:created>
  <dc:creator>Saskia</dc:creator>
  <dc:description/>
  <dc:language>en-US</dc:language>
  <cp:lastModifiedBy>Ky.Shilpashree</cp:lastModifiedBy>
  <cp:lastPrinted>2016-08-12T14:03:43Z</cp:lastPrinted>
  <dcterms:modified xsi:type="dcterms:W3CDTF">2016-12-23T11:51:44Z</dcterms:modified>
  <cp:revision>20</cp:revision>
  <dc:subject/>
  <dc:title>PowerPoint Presentation</dc:title>
</cp:coreProperties>
</file>